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E78E3E-E85E-4564-87FF-78EA6642DEF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098A99-ADE2-44F6-B86D-9262419234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CF4B92-EE44-45D0-A955-196BF0E9F1D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A8AC62-6BDD-45F4-B4F7-DD7E7343274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454E75-45E4-463E-9A08-BA20E78A23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2E63A6-2A10-48A7-8853-AD7A60ACC5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EEE21D-5595-442C-802D-DE98B74BCE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C6E902-3106-44F4-867F-E1A4B25F25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63BB1D-10A3-4C1B-BDB6-9744CB5FE2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CEF231-0211-4103-B5B0-C891A5751E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303AA1-A59F-4D48-A4F1-6FC9CE1AC1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74FBA8-CD2D-4281-82B9-152843A5C2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571A8B-DF69-44FE-A614-3B78A3749DA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79280" y="333360"/>
          <a:ext cx="8713440" cy="3156120"/>
        </p:xfrm>
        <a:graphic>
          <a:graphicData uri="http://schemas.openxmlformats.org/drawingml/2006/table">
            <a:tbl>
              <a:tblPr/>
              <a:tblGrid>
                <a:gridCol w="1208880"/>
                <a:gridCol w="1056600"/>
                <a:gridCol w="1962360"/>
                <a:gridCol w="4485600"/>
              </a:tblGrid>
              <a:tr h="249480">
                <a:tc gridSpan="4"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Supplementary Table 4               Summary of international resolutions and codes relating to health worker migration </a:t>
                      </a: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(abbreviations listed at end of manuscript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665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Year of resolution or cod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3f3f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Type of resolution or cod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3f3f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Resolution or cod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3f3f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Summary of conten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3f3f3"/>
                    </a:solidFill>
                  </a:tcPr>
                </a:tc>
              </a:tr>
              <a:tr h="4683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003 (May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Commonwealth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Commonwealth Code of Practice for the international recruitment of health workers.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The Code was intended to discourage targeted recruitment of health workers from countries already experiencing shortages. The Code was voluntary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The UK has not signed this agreement to date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174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004 (May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World Health Assembl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Resolution WHA57.19 International migration of health personnel: a challenge for health systems in developing countries.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Called for the Director General of WHO to establish a CP, as well as independent monitoring and research into international migration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238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008 (March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Global Forum on Human Resources for Healt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Kampala Declaration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Called for international collaboration in addressing the human resources crisis in the health workforce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303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2010 (May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WHO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WHO Global Code of Practice on the International Recruitment of Health Personnel</a:t>
                      </a:r>
                      <a:r>
                        <a:rPr b="0" lang="en-US" sz="800" spc="-1" strike="noStrike" baseline="30000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Objectives of this CP included: to establish and promote ethical recruitment principles, to serve as a reference for legal/ institutional improvements, to provide guidance for MoUs etc., to facilitate discussion and cooperation with particular focus on strengthening health systems in developing countries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432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15T16:03:45Z</dcterms:created>
  <dc:creator>cblacklock</dc:creator>
  <dc:description/>
  <dc:language>en-US</dc:language>
  <cp:lastModifiedBy>cblacklock</cp:lastModifiedBy>
  <dcterms:modified xsi:type="dcterms:W3CDTF">2011-11-24T18:10:52Z</dcterms:modified>
  <cp:revision>10</cp:revision>
  <dc:subject/>
  <dc:title>Slide 1</dc:title>
</cp:coreProperties>
</file>